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3D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368" y="480"/>
      </p:cViewPr>
      <p:guideLst>
        <p:guide orient="horz" pos="2316"/>
        <p:guide pos="288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rusawayukihiro:Google%20&#12489;&#12521;&#12452;&#12502;:HUVEC:HUVEC%20qPCR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rusawayukihiro:Google%20&#12489;&#12521;&#12452;&#12502;:HUVEC:HUVEC%20qPCR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rusawayukihiro:Google%20&#12489;&#12521;&#12452;&#12502;:HUVEC:HUVEC%20qPCR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rusawayukihiro:Google%20&#12489;&#12521;&#12452;&#12502;:HUVEC:HUVEC%20qPCR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rusawayukihiro:Google%20&#12489;&#12521;&#12452;&#12502;:HUVEC:HUVEC%20qPCR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rusawayukihiro:Google%20&#12489;&#12521;&#12452;&#12502;:HUVEC:HUVEC%20qPCR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O$1</c:f>
              <c:strCache>
                <c:ptCount val="1"/>
                <c:pt idx="0">
                  <c:v>IFIT1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2:$P$5</c:f>
                <c:numCache>
                  <c:formatCode>General</c:formatCode>
                  <c:ptCount val="4"/>
                  <c:pt idx="0">
                    <c:v>3.60927048404185E-5</c:v>
                  </c:pt>
                  <c:pt idx="1">
                    <c:v>1.93638200034662E-5</c:v>
                  </c:pt>
                  <c:pt idx="2">
                    <c:v>2.7323307522353E-5</c:v>
                  </c:pt>
                  <c:pt idx="3">
                    <c:v>3.20102753229112E-5</c:v>
                  </c:pt>
                </c:numCache>
              </c:numRef>
            </c:plus>
            <c:minus>
              <c:numRef>
                <c:f>Sheet1!$P$2:$P$5</c:f>
                <c:numCache>
                  <c:formatCode>General</c:formatCode>
                  <c:ptCount val="4"/>
                  <c:pt idx="0">
                    <c:v>3.60927048404185E-5</c:v>
                  </c:pt>
                  <c:pt idx="1">
                    <c:v>1.93638200034662E-5</c:v>
                  </c:pt>
                  <c:pt idx="2">
                    <c:v>2.7323307522353E-5</c:v>
                  </c:pt>
                  <c:pt idx="3">
                    <c:v>3.20102753229112E-5</c:v>
                  </c:pt>
                </c:numCache>
              </c:numRef>
            </c:minus>
          </c:errBars>
          <c:xVal>
            <c:numRef>
              <c:f>Sheet1!$N$2:$N$5</c:f>
              <c:numCache>
                <c:formatCode>0_ </c:formatCode>
                <c:ptCount val="4"/>
                <c:pt idx="0">
                  <c:v>0.0</c:v>
                </c:pt>
                <c:pt idx="1">
                  <c:v>6.0</c:v>
                </c:pt>
                <c:pt idx="2">
                  <c:v>12.0</c:v>
                </c:pt>
                <c:pt idx="3">
                  <c:v>24.0</c:v>
                </c:pt>
              </c:numCache>
            </c:numRef>
          </c:xVal>
          <c:yVal>
            <c:numRef>
              <c:f>Sheet1!$O$2:$O$5</c:f>
              <c:numCache>
                <c:formatCode>0.00000_ </c:formatCode>
                <c:ptCount val="4"/>
                <c:pt idx="0">
                  <c:v>0.000100771721980535</c:v>
                </c:pt>
                <c:pt idx="1">
                  <c:v>0.000128984362834493</c:v>
                </c:pt>
                <c:pt idx="2">
                  <c:v>0.000109607523095202</c:v>
                </c:pt>
                <c:pt idx="3">
                  <c:v>0.00026436389407432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69656056"/>
        <c:axId val="-2068286632"/>
      </c:scatterChart>
      <c:valAx>
        <c:axId val="-2069656056"/>
        <c:scaling>
          <c:orientation val="minMax"/>
          <c:max val="24.0"/>
          <c:min val="0.0"/>
        </c:scaling>
        <c:delete val="0"/>
        <c:axPos val="b"/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68286632"/>
        <c:crosses val="autoZero"/>
        <c:crossBetween val="midCat"/>
        <c:majorUnit val="6.0"/>
      </c:valAx>
      <c:valAx>
        <c:axId val="-2068286632"/>
        <c:scaling>
          <c:orientation val="minMax"/>
          <c:max val="0.0004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Times New Roman"/>
                    <a:cs typeface="Times New Roman"/>
                  </a:defRPr>
                </a:pPr>
                <a:r>
                  <a:rPr lang="en-US" altLang="ja-JP">
                    <a:latin typeface="Times New Roman"/>
                    <a:cs typeface="Times New Roman"/>
                  </a:rPr>
                  <a:t>IFIT1//GAPDH</a:t>
                </a:r>
                <a:endParaRPr lang="ja-JP" altLang="en-US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424446831364125"/>
              <c:y val="0.242706733812158"/>
            </c:manualLayout>
          </c:layout>
          <c:overlay val="0"/>
        </c:title>
        <c:numFmt formatCode="0.0000_ 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69656056"/>
        <c:crosses val="autoZero"/>
        <c:crossBetween val="midCat"/>
        <c:majorUnit val="0.000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O$26</c:f>
              <c:strCache>
                <c:ptCount val="1"/>
                <c:pt idx="0">
                  <c:v>IFIT3_1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27:$P$30</c:f>
                <c:numCache>
                  <c:formatCode>General</c:formatCode>
                  <c:ptCount val="4"/>
                  <c:pt idx="0">
                    <c:v>3.83700662413585E-5</c:v>
                  </c:pt>
                  <c:pt idx="1">
                    <c:v>0.000105969434472517</c:v>
                  </c:pt>
                  <c:pt idx="2">
                    <c:v>0.000127862926889863</c:v>
                  </c:pt>
                  <c:pt idx="3">
                    <c:v>6.95827057078603E-5</c:v>
                  </c:pt>
                </c:numCache>
              </c:numRef>
            </c:plus>
            <c:minus>
              <c:numRef>
                <c:f>Sheet1!$P$27:$P$30</c:f>
                <c:numCache>
                  <c:formatCode>General</c:formatCode>
                  <c:ptCount val="4"/>
                  <c:pt idx="0">
                    <c:v>3.83700662413585E-5</c:v>
                  </c:pt>
                  <c:pt idx="1">
                    <c:v>0.000105969434472517</c:v>
                  </c:pt>
                  <c:pt idx="2">
                    <c:v>0.000127862926889863</c:v>
                  </c:pt>
                  <c:pt idx="3">
                    <c:v>6.95827057078603E-5</c:v>
                  </c:pt>
                </c:numCache>
              </c:numRef>
            </c:minus>
          </c:errBars>
          <c:xVal>
            <c:numRef>
              <c:f>Sheet1!$N$27:$N$30</c:f>
              <c:numCache>
                <c:formatCode>0_ </c:formatCode>
                <c:ptCount val="4"/>
                <c:pt idx="0">
                  <c:v>0.0</c:v>
                </c:pt>
                <c:pt idx="1">
                  <c:v>6.0</c:v>
                </c:pt>
                <c:pt idx="2">
                  <c:v>12.0</c:v>
                </c:pt>
                <c:pt idx="3">
                  <c:v>24.0</c:v>
                </c:pt>
              </c:numCache>
            </c:numRef>
          </c:xVal>
          <c:yVal>
            <c:numRef>
              <c:f>Sheet1!$O$27:$O$30</c:f>
              <c:numCache>
                <c:formatCode>0.00000_ </c:formatCode>
                <c:ptCount val="4"/>
                <c:pt idx="0">
                  <c:v>0.000341153574254663</c:v>
                </c:pt>
                <c:pt idx="1">
                  <c:v>0.00044765212451834</c:v>
                </c:pt>
                <c:pt idx="2">
                  <c:v>0.000390736195164166</c:v>
                </c:pt>
                <c:pt idx="3">
                  <c:v>0.0004900698328439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70675704"/>
        <c:axId val="-2087188776"/>
      </c:scatterChart>
      <c:valAx>
        <c:axId val="2070675704"/>
        <c:scaling>
          <c:orientation val="minMax"/>
          <c:max val="24.0"/>
          <c:min val="0.0"/>
        </c:scaling>
        <c:delete val="0"/>
        <c:axPos val="b"/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87188776"/>
        <c:crosses val="autoZero"/>
        <c:crossBetween val="midCat"/>
        <c:majorUnit val="6.0"/>
      </c:valAx>
      <c:valAx>
        <c:axId val="-2087188776"/>
        <c:scaling>
          <c:orientation val="minMax"/>
          <c:max val="0.0006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Times New Roman"/>
                    <a:cs typeface="Times New Roman"/>
                  </a:defRPr>
                </a:pPr>
                <a:r>
                  <a:rPr lang="en-US" altLang="ja-JP">
                    <a:latin typeface="Times New Roman"/>
                    <a:cs typeface="Times New Roman"/>
                  </a:rPr>
                  <a:t>IFIT3//GAPDH</a:t>
                </a:r>
                <a:endParaRPr lang="ja-JP" altLang="en-US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424446831364125"/>
              <c:y val="0.242706733812158"/>
            </c:manualLayout>
          </c:layout>
          <c:overlay val="0"/>
        </c:title>
        <c:numFmt formatCode="0.0000_ 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2070675704"/>
        <c:crosses val="autoZero"/>
        <c:crossBetween val="midCat"/>
        <c:majorUnit val="0.0002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O$76</c:f>
              <c:strCache>
                <c:ptCount val="1"/>
                <c:pt idx="0">
                  <c:v>IRF7_2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77:$P$80</c:f>
                <c:numCache>
                  <c:formatCode>General</c:formatCode>
                  <c:ptCount val="4"/>
                  <c:pt idx="0">
                    <c:v>0.000361828859691859</c:v>
                  </c:pt>
                  <c:pt idx="1">
                    <c:v>0.00108385035550058</c:v>
                  </c:pt>
                  <c:pt idx="2">
                    <c:v>0.000596711290277728</c:v>
                  </c:pt>
                  <c:pt idx="3">
                    <c:v>0.000376953784524539</c:v>
                  </c:pt>
                </c:numCache>
              </c:numRef>
            </c:plus>
            <c:minus>
              <c:numRef>
                <c:f>Sheet1!$P$77:$P$80</c:f>
                <c:numCache>
                  <c:formatCode>General</c:formatCode>
                  <c:ptCount val="4"/>
                  <c:pt idx="0">
                    <c:v>0.000361828859691859</c:v>
                  </c:pt>
                  <c:pt idx="1">
                    <c:v>0.00108385035550058</c:v>
                  </c:pt>
                  <c:pt idx="2">
                    <c:v>0.000596711290277728</c:v>
                  </c:pt>
                  <c:pt idx="3">
                    <c:v>0.000376953784524539</c:v>
                  </c:pt>
                </c:numCache>
              </c:numRef>
            </c:minus>
          </c:errBars>
          <c:xVal>
            <c:numRef>
              <c:f>Sheet1!$N$77:$N$80</c:f>
              <c:numCache>
                <c:formatCode>0_ </c:formatCode>
                <c:ptCount val="4"/>
                <c:pt idx="0">
                  <c:v>0.0</c:v>
                </c:pt>
                <c:pt idx="1">
                  <c:v>6.0</c:v>
                </c:pt>
                <c:pt idx="2">
                  <c:v>12.0</c:v>
                </c:pt>
                <c:pt idx="3">
                  <c:v>24.0</c:v>
                </c:pt>
              </c:numCache>
            </c:numRef>
          </c:xVal>
          <c:yVal>
            <c:numRef>
              <c:f>Sheet1!$O$77:$O$80</c:f>
              <c:numCache>
                <c:formatCode>0.00000_ </c:formatCode>
                <c:ptCount val="4"/>
                <c:pt idx="0">
                  <c:v>0.00266180301064599</c:v>
                </c:pt>
                <c:pt idx="1">
                  <c:v>0.00377483779521186</c:v>
                </c:pt>
                <c:pt idx="2">
                  <c:v>0.00320768300207375</c:v>
                </c:pt>
                <c:pt idx="3">
                  <c:v>0.006371789080410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70165624"/>
        <c:axId val="-2070162552"/>
      </c:scatterChart>
      <c:valAx>
        <c:axId val="-2070165624"/>
        <c:scaling>
          <c:orientation val="minMax"/>
          <c:max val="24.0"/>
          <c:min val="0.0"/>
        </c:scaling>
        <c:delete val="0"/>
        <c:axPos val="b"/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70162552"/>
        <c:crosses val="autoZero"/>
        <c:crossBetween val="midCat"/>
        <c:majorUnit val="6.0"/>
      </c:valAx>
      <c:valAx>
        <c:axId val="-2070162552"/>
        <c:scaling>
          <c:orientation val="minMax"/>
          <c:max val="0.008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Times New Roman"/>
                    <a:cs typeface="Times New Roman"/>
                  </a:defRPr>
                </a:pPr>
                <a:r>
                  <a:rPr lang="en-US" altLang="ja-JP">
                    <a:latin typeface="Times New Roman"/>
                    <a:cs typeface="Times New Roman"/>
                  </a:rPr>
                  <a:t>IRF7//GAPDH</a:t>
                </a:r>
                <a:endParaRPr lang="ja-JP" altLang="en-US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424446831364125"/>
              <c:y val="0.256686204903822"/>
            </c:manualLayout>
          </c:layout>
          <c:overlay val="0"/>
        </c:title>
        <c:numFmt formatCode="0.000_ 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70165624"/>
        <c:crosses val="autoZero"/>
        <c:crossBetween val="midCat"/>
        <c:majorUnit val="0.002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O$101</c:f>
              <c:strCache>
                <c:ptCount val="1"/>
                <c:pt idx="0">
                  <c:v>Mx1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102:$P$105</c:f>
                <c:numCache>
                  <c:formatCode>General</c:formatCode>
                  <c:ptCount val="4"/>
                  <c:pt idx="0">
                    <c:v>9.05880186359527E-5</c:v>
                  </c:pt>
                  <c:pt idx="1">
                    <c:v>0.000135564309872532</c:v>
                  </c:pt>
                  <c:pt idx="2">
                    <c:v>6.07944854463687E-5</c:v>
                  </c:pt>
                  <c:pt idx="3">
                    <c:v>6.84075865174824E-5</c:v>
                  </c:pt>
                </c:numCache>
              </c:numRef>
            </c:plus>
            <c:minus>
              <c:numRef>
                <c:f>Sheet1!$P$102:$P$105</c:f>
                <c:numCache>
                  <c:formatCode>General</c:formatCode>
                  <c:ptCount val="4"/>
                  <c:pt idx="0">
                    <c:v>9.05880186359527E-5</c:v>
                  </c:pt>
                  <c:pt idx="1">
                    <c:v>0.000135564309872532</c:v>
                  </c:pt>
                  <c:pt idx="2">
                    <c:v>6.07944854463687E-5</c:v>
                  </c:pt>
                  <c:pt idx="3">
                    <c:v>6.84075865174824E-5</c:v>
                  </c:pt>
                </c:numCache>
              </c:numRef>
            </c:minus>
          </c:errBars>
          <c:xVal>
            <c:numRef>
              <c:f>Sheet1!$N$102:$N$105</c:f>
              <c:numCache>
                <c:formatCode>0_ </c:formatCode>
                <c:ptCount val="4"/>
                <c:pt idx="0">
                  <c:v>0.0</c:v>
                </c:pt>
                <c:pt idx="1">
                  <c:v>6.0</c:v>
                </c:pt>
                <c:pt idx="2">
                  <c:v>12.0</c:v>
                </c:pt>
                <c:pt idx="3">
                  <c:v>24.0</c:v>
                </c:pt>
              </c:numCache>
            </c:numRef>
          </c:xVal>
          <c:yVal>
            <c:numRef>
              <c:f>Sheet1!$O$102:$O$105</c:f>
              <c:numCache>
                <c:formatCode>0.00000_ </c:formatCode>
                <c:ptCount val="4"/>
                <c:pt idx="0">
                  <c:v>0.000460063685877737</c:v>
                </c:pt>
                <c:pt idx="1">
                  <c:v>0.000522626963048108</c:v>
                </c:pt>
                <c:pt idx="2">
                  <c:v>0.000486752153283161</c:v>
                </c:pt>
                <c:pt idx="3">
                  <c:v>0.00070250230488131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70315064"/>
        <c:axId val="-2070311992"/>
      </c:scatterChart>
      <c:valAx>
        <c:axId val="-2070315064"/>
        <c:scaling>
          <c:orientation val="minMax"/>
          <c:max val="24.0"/>
          <c:min val="0.0"/>
        </c:scaling>
        <c:delete val="0"/>
        <c:axPos val="b"/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70311992"/>
        <c:crosses val="autoZero"/>
        <c:crossBetween val="midCat"/>
        <c:majorUnit val="6.0"/>
      </c:valAx>
      <c:valAx>
        <c:axId val="-2070311992"/>
        <c:scaling>
          <c:orientation val="minMax"/>
          <c:max val="0.0008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Times New Roman"/>
                    <a:cs typeface="Times New Roman"/>
                  </a:defRPr>
                </a:pPr>
                <a:r>
                  <a:rPr lang="en-US" altLang="ja-JP">
                    <a:latin typeface="Times New Roman"/>
                    <a:cs typeface="Times New Roman"/>
                  </a:rPr>
                  <a:t>Mx1//GAPDH</a:t>
                </a:r>
                <a:endParaRPr lang="ja-JP" altLang="en-US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424446831364125"/>
              <c:y val="0.263675940449655"/>
            </c:manualLayout>
          </c:layout>
          <c:overlay val="0"/>
        </c:title>
        <c:numFmt formatCode="0.0000_ 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70315064"/>
        <c:crosses val="autoZero"/>
        <c:crossBetween val="midCat"/>
        <c:majorUnit val="0.0002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O$126</c:f>
              <c:strCache>
                <c:ptCount val="1"/>
                <c:pt idx="0">
                  <c:v>TLR3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127:$P$130</c:f>
                <c:numCache>
                  <c:formatCode>General</c:formatCode>
                  <c:ptCount val="4"/>
                  <c:pt idx="0">
                    <c:v>6.90685390951458E-5</c:v>
                  </c:pt>
                  <c:pt idx="1">
                    <c:v>0.000157513923262269</c:v>
                  </c:pt>
                  <c:pt idx="2">
                    <c:v>0.000107395355470468</c:v>
                  </c:pt>
                  <c:pt idx="3">
                    <c:v>5.94789517492621E-5</c:v>
                  </c:pt>
                </c:numCache>
              </c:numRef>
            </c:plus>
            <c:minus>
              <c:numRef>
                <c:f>Sheet1!$P$127:$P$130</c:f>
                <c:numCache>
                  <c:formatCode>General</c:formatCode>
                  <c:ptCount val="4"/>
                  <c:pt idx="0">
                    <c:v>6.90685390951458E-5</c:v>
                  </c:pt>
                  <c:pt idx="1">
                    <c:v>0.000157513923262269</c:v>
                  </c:pt>
                  <c:pt idx="2">
                    <c:v>0.000107395355470468</c:v>
                  </c:pt>
                  <c:pt idx="3">
                    <c:v>5.94789517492621E-5</c:v>
                  </c:pt>
                </c:numCache>
              </c:numRef>
            </c:minus>
          </c:errBars>
          <c:xVal>
            <c:numRef>
              <c:f>Sheet1!$N$127:$N$130</c:f>
              <c:numCache>
                <c:formatCode>0_ </c:formatCode>
                <c:ptCount val="4"/>
                <c:pt idx="0">
                  <c:v>0.0</c:v>
                </c:pt>
                <c:pt idx="1">
                  <c:v>6.0</c:v>
                </c:pt>
                <c:pt idx="2">
                  <c:v>12.0</c:v>
                </c:pt>
                <c:pt idx="3">
                  <c:v>24.0</c:v>
                </c:pt>
              </c:numCache>
            </c:numRef>
          </c:xVal>
          <c:yVal>
            <c:numRef>
              <c:f>Sheet1!$O$127:$O$130</c:f>
              <c:numCache>
                <c:formatCode>0.00000_ </c:formatCode>
                <c:ptCount val="4"/>
                <c:pt idx="0">
                  <c:v>0.000401834933840376</c:v>
                </c:pt>
                <c:pt idx="1">
                  <c:v>0.000462045299131473</c:v>
                </c:pt>
                <c:pt idx="2">
                  <c:v>0.00037320008730987</c:v>
                </c:pt>
                <c:pt idx="3">
                  <c:v>0.00056701061884783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70285864"/>
        <c:axId val="-2070282792"/>
      </c:scatterChart>
      <c:valAx>
        <c:axId val="-2070285864"/>
        <c:scaling>
          <c:orientation val="minMax"/>
          <c:max val="24.0"/>
          <c:min val="0.0"/>
        </c:scaling>
        <c:delete val="0"/>
        <c:axPos val="b"/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70282792"/>
        <c:crosses val="autoZero"/>
        <c:crossBetween val="midCat"/>
        <c:majorUnit val="6.0"/>
      </c:valAx>
      <c:valAx>
        <c:axId val="-2070282792"/>
        <c:scaling>
          <c:orientation val="minMax"/>
          <c:max val="0.0008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Times New Roman"/>
                    <a:cs typeface="Times New Roman"/>
                  </a:defRPr>
                </a:pPr>
                <a:r>
                  <a:rPr lang="en-US" altLang="ja-JP">
                    <a:latin typeface="Times New Roman"/>
                    <a:cs typeface="Times New Roman"/>
                  </a:rPr>
                  <a:t>TLR3//GAPDH</a:t>
                </a:r>
                <a:endParaRPr lang="ja-JP" altLang="en-US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424446831364125"/>
              <c:y val="0.242706733812158"/>
            </c:manualLayout>
          </c:layout>
          <c:overlay val="0"/>
        </c:title>
        <c:numFmt formatCode="0.0000_ 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70285864"/>
        <c:crosses val="autoZero"/>
        <c:crossBetween val="midCat"/>
        <c:majorUnit val="0.0002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O$226</c:f>
              <c:strCache>
                <c:ptCount val="1"/>
                <c:pt idx="0">
                  <c:v>TICAM1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227:$P$230</c:f>
                <c:numCache>
                  <c:formatCode>General</c:formatCode>
                  <c:ptCount val="4"/>
                  <c:pt idx="0">
                    <c:v>0.000836404591270438</c:v>
                  </c:pt>
                  <c:pt idx="1">
                    <c:v>0.00107672242926278</c:v>
                  </c:pt>
                  <c:pt idx="2">
                    <c:v>0.00181878987986015</c:v>
                  </c:pt>
                  <c:pt idx="3">
                    <c:v>0.00243780789868061</c:v>
                  </c:pt>
                </c:numCache>
              </c:numRef>
            </c:plus>
            <c:minus>
              <c:numRef>
                <c:f>Sheet1!$P$227:$P$230</c:f>
                <c:numCache>
                  <c:formatCode>General</c:formatCode>
                  <c:ptCount val="4"/>
                  <c:pt idx="0">
                    <c:v>0.000836404591270438</c:v>
                  </c:pt>
                  <c:pt idx="1">
                    <c:v>0.00107672242926278</c:v>
                  </c:pt>
                  <c:pt idx="2">
                    <c:v>0.00181878987986015</c:v>
                  </c:pt>
                  <c:pt idx="3">
                    <c:v>0.00243780789868061</c:v>
                  </c:pt>
                </c:numCache>
              </c:numRef>
            </c:minus>
          </c:errBars>
          <c:xVal>
            <c:numRef>
              <c:f>Sheet1!$N$227:$N$230</c:f>
              <c:numCache>
                <c:formatCode>0_ </c:formatCode>
                <c:ptCount val="4"/>
                <c:pt idx="0">
                  <c:v>0.0</c:v>
                </c:pt>
                <c:pt idx="1">
                  <c:v>6.0</c:v>
                </c:pt>
                <c:pt idx="2">
                  <c:v>12.0</c:v>
                </c:pt>
                <c:pt idx="3">
                  <c:v>24.0</c:v>
                </c:pt>
              </c:numCache>
            </c:numRef>
          </c:xVal>
          <c:yVal>
            <c:numRef>
              <c:f>Sheet1!$O$227:$O$230</c:f>
              <c:numCache>
                <c:formatCode>0.00000_ </c:formatCode>
                <c:ptCount val="4"/>
                <c:pt idx="0">
                  <c:v>0.00963749157923441</c:v>
                </c:pt>
                <c:pt idx="1">
                  <c:v>0.0111784819120894</c:v>
                </c:pt>
                <c:pt idx="2">
                  <c:v>0.0122145699902372</c:v>
                </c:pt>
                <c:pt idx="3">
                  <c:v>0.0144800393077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70254040"/>
        <c:axId val="-2070250632"/>
      </c:scatterChart>
      <c:valAx>
        <c:axId val="-2070254040"/>
        <c:scaling>
          <c:orientation val="minMax"/>
          <c:max val="24.0"/>
          <c:min val="0.0"/>
        </c:scaling>
        <c:delete val="0"/>
        <c:axPos val="b"/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70250632"/>
        <c:crosses val="autoZero"/>
        <c:crossBetween val="midCat"/>
        <c:majorUnit val="6.0"/>
      </c:valAx>
      <c:valAx>
        <c:axId val="-207025063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Times New Roman"/>
                    <a:cs typeface="Times New Roman"/>
                  </a:defRPr>
                </a:pPr>
                <a:r>
                  <a:rPr lang="en-US" altLang="ja-JP">
                    <a:latin typeface="Times New Roman"/>
                    <a:cs typeface="Times New Roman"/>
                  </a:rPr>
                  <a:t>TICAM1/GAPDH</a:t>
                </a:r>
                <a:endParaRPr lang="ja-JP" altLang="en-US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325237769749048"/>
              <c:y val="0.200768320537164"/>
            </c:manualLayout>
          </c:layout>
          <c:overlay val="0"/>
        </c:title>
        <c:numFmt formatCode="0.000_ 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ja-JP"/>
          </a:p>
        </c:txPr>
        <c:crossAx val="-2070254040"/>
        <c:crosses val="autoZero"/>
        <c:crossBetween val="midCat"/>
        <c:majorUnit val="0.005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3637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4661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858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3142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514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589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533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760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4165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680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5055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4C067A-DCA4-9143-838A-B0456702BA2A}" type="datetimeFigureOut">
              <a:rPr kumimoji="1" lang="ja-JP" altLang="en-US" smtClean="0"/>
              <a:t>16/0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6D4CE8-EC57-3C49-9785-9E5D64EDC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9567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図形グループ 15"/>
          <p:cNvGrpSpPr>
            <a:grpSpLocks noChangeAspect="1"/>
          </p:cNvGrpSpPr>
          <p:nvPr/>
        </p:nvGrpSpPr>
        <p:grpSpPr>
          <a:xfrm>
            <a:off x="635571" y="1262600"/>
            <a:ext cx="7731956" cy="3887994"/>
            <a:chOff x="59839" y="873132"/>
            <a:chExt cx="9036205" cy="4543835"/>
          </a:xfrm>
        </p:grpSpPr>
        <p:graphicFrame>
          <p:nvGraphicFramePr>
            <p:cNvPr id="4" name="グラフ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05023381"/>
                </p:ext>
              </p:extLst>
            </p:nvPr>
          </p:nvGraphicFramePr>
          <p:xfrm>
            <a:off x="59839" y="873132"/>
            <a:ext cx="2992120" cy="2123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グラフ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4283118"/>
                </p:ext>
              </p:extLst>
            </p:nvPr>
          </p:nvGraphicFramePr>
          <p:xfrm>
            <a:off x="3051959" y="873132"/>
            <a:ext cx="2992120" cy="2123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グラフ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80791856"/>
                </p:ext>
              </p:extLst>
            </p:nvPr>
          </p:nvGraphicFramePr>
          <p:xfrm>
            <a:off x="6103924" y="873132"/>
            <a:ext cx="2992120" cy="2123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グラフ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9167866"/>
                </p:ext>
              </p:extLst>
            </p:nvPr>
          </p:nvGraphicFramePr>
          <p:xfrm>
            <a:off x="59839" y="3142400"/>
            <a:ext cx="2992120" cy="2123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8" name="グラフ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47347769"/>
                </p:ext>
              </p:extLst>
            </p:nvPr>
          </p:nvGraphicFramePr>
          <p:xfrm>
            <a:off x="3051959" y="3142400"/>
            <a:ext cx="2992120" cy="2123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9" name="グラフ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87750033"/>
                </p:ext>
              </p:extLst>
            </p:nvPr>
          </p:nvGraphicFramePr>
          <p:xfrm>
            <a:off x="6103924" y="3142400"/>
            <a:ext cx="2992120" cy="2123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0" name="テキスト ボックス 9"/>
            <p:cNvSpPr txBox="1"/>
            <p:nvPr/>
          </p:nvSpPr>
          <p:spPr>
            <a:xfrm>
              <a:off x="1307286" y="2873461"/>
              <a:ext cx="11237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 smtClean="0">
                  <a:latin typeface="Times New Roman"/>
                  <a:cs typeface="Times New Roman"/>
                </a:rPr>
                <a:t>Time after IR (h)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4326375" y="2873461"/>
              <a:ext cx="11237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 smtClean="0">
                  <a:latin typeface="Times New Roman"/>
                  <a:cs typeface="Times New Roman"/>
                </a:rPr>
                <a:t>Time after IR (h)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7345469" y="2873461"/>
              <a:ext cx="11237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 smtClean="0">
                  <a:latin typeface="Times New Roman"/>
                  <a:cs typeface="Times New Roman"/>
                </a:rPr>
                <a:t>Time after IR (h)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316624" y="5170746"/>
              <a:ext cx="11237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 smtClean="0">
                  <a:latin typeface="Times New Roman"/>
                  <a:cs typeface="Times New Roman"/>
                </a:rPr>
                <a:t>Time after IR (h)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4335713" y="5170746"/>
              <a:ext cx="11237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 smtClean="0">
                  <a:latin typeface="Times New Roman"/>
                  <a:cs typeface="Times New Roman"/>
                </a:rPr>
                <a:t>Time after IR (h)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7354807" y="5170746"/>
              <a:ext cx="11237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 smtClean="0">
                  <a:latin typeface="Times New Roman"/>
                  <a:cs typeface="Times New Roman"/>
                </a:rPr>
                <a:t>Time after IR (h)</a:t>
              </a:r>
              <a:endParaRPr kumimoji="1" lang="ja-JP" altLang="en-US" sz="1000" b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17" name="テキスト ボックス 16"/>
          <p:cNvSpPr txBox="1"/>
          <p:nvPr/>
        </p:nvSpPr>
        <p:spPr>
          <a:xfrm>
            <a:off x="6189133" y="6399768"/>
            <a:ext cx="2887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Supplementary </a:t>
            </a:r>
            <a:r>
              <a:rPr lang="en-US" altLang="ja-JP" dirty="0" smtClean="0"/>
              <a:t>Figure</a:t>
            </a:r>
            <a:r>
              <a:rPr lang="en-US" altLang="ja-JP" dirty="0" smtClean="0"/>
              <a:t> </a:t>
            </a:r>
            <a:r>
              <a:rPr lang="en-US" altLang="ja-JP" dirty="0"/>
              <a:t>1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109133" y="5520267"/>
            <a:ext cx="726179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 New Roman"/>
                <a:cs typeface="Times New Roman"/>
              </a:rPr>
              <a:t>Supplementary Figure 1. </a:t>
            </a:r>
            <a:r>
              <a:rPr lang="en-US" altLang="ja-JP" sz="1200" dirty="0" smtClean="0">
                <a:latin typeface="Times New Roman"/>
                <a:cs typeface="Times New Roman"/>
              </a:rPr>
              <a:t>Verification </a:t>
            </a:r>
            <a:r>
              <a:rPr kumimoji="1" lang="en-US" altLang="ja-JP" sz="1200" dirty="0" smtClean="0">
                <a:latin typeface="Times New Roman"/>
                <a:cs typeface="Times New Roman"/>
              </a:rPr>
              <a:t>of microarray results by real-time </a:t>
            </a:r>
            <a:r>
              <a:rPr kumimoji="1" lang="en-US" altLang="ja-JP" sz="1200" dirty="0" err="1" smtClean="0">
                <a:latin typeface="Times New Roman"/>
                <a:cs typeface="Times New Roman"/>
              </a:rPr>
              <a:t>qPCR</a:t>
            </a:r>
            <a:r>
              <a:rPr kumimoji="1" lang="en-US" altLang="ja-JP" sz="1200" dirty="0" smtClean="0">
                <a:latin typeface="Times New Roman"/>
                <a:cs typeface="Times New Roman"/>
              </a:rPr>
              <a:t>. HUVEC cells were irradiated with</a:t>
            </a:r>
          </a:p>
          <a:p>
            <a:r>
              <a:rPr lang="en-US" altLang="ja-JP" sz="1200" dirty="0" smtClean="0">
                <a:latin typeface="Times New Roman"/>
                <a:cs typeface="Times New Roman"/>
              </a:rPr>
              <a:t>2.5 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Gy</a:t>
            </a:r>
            <a:r>
              <a:rPr lang="en-US" altLang="ja-JP" sz="1200" dirty="0" smtClean="0">
                <a:latin typeface="Times New Roman"/>
                <a:cs typeface="Times New Roman"/>
              </a:rPr>
              <a:t> IR and then cultured for 6, 12 and 24 h. Each expression level was normalized to GAPDH expression level.</a:t>
            </a:r>
          </a:p>
          <a:p>
            <a:r>
              <a:rPr kumimoji="1" lang="en-US" altLang="ja-JP" sz="1200" dirty="0" smtClean="0">
                <a:latin typeface="Times New Roman"/>
                <a:cs typeface="Times New Roman"/>
              </a:rPr>
              <a:t>Data are presented as means 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92463222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11</TotalTime>
  <Words>110</Words>
  <Application>Microsoft Macintosh PowerPoint</Application>
  <PresentationFormat>画面に合わせる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東京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古澤 之裕</dc:creator>
  <cp:lastModifiedBy>古澤 之裕</cp:lastModifiedBy>
  <cp:revision>42</cp:revision>
  <dcterms:created xsi:type="dcterms:W3CDTF">2014-08-18T06:52:37Z</dcterms:created>
  <dcterms:modified xsi:type="dcterms:W3CDTF">2016-05-12T03:34:07Z</dcterms:modified>
</cp:coreProperties>
</file>